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AB02B4-071F-44CB-9D36-6ED46BB47A6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98530E-D3EB-410E-BF53-9F0F2375B8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B296A-7CF5-4207-B71D-B613BEAC0A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9FE38F-D188-4DA9-B21A-A0BA668096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4D5209-E358-4EF4-AEA2-179492885F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8BD037-6C99-4F00-BF69-767AF8A7FC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AD00A-0401-4125-980E-02A4F9C6BC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C265D-8974-417B-85F7-659A066CA2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74178B-A5F7-496A-B785-11C66E1760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EA7BCA-B808-442C-8441-31B4487246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DE0A7-F4ED-40D5-B351-F8CF244D72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9AD7A7-83A4-42A0-A5F3-1A5AE135FE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85C025-922D-4403-BDFB-522F2CD09CBE}" type="slidenum">
              <a:rPr b="0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116000" y="115920"/>
            <a:ext cx="2089080" cy="3785760"/>
            <a:chOff x="1116000" y="115920"/>
            <a:chExt cx="2089080" cy="378576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1243440" y="373680"/>
              <a:ext cx="1773000" cy="352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1116000" y="115920"/>
              <a:ext cx="2089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8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pl-PL" sz="1200" spc="-1" strike="noStrike">
                  <a:solidFill>
                    <a:srgbClr val="000000"/>
                  </a:solidFill>
                  <a:latin typeface="Arial"/>
                </a:rPr>
                <a:t>1      2      3    4    5     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" name=""/>
          <p:cNvSpPr/>
          <p:nvPr/>
        </p:nvSpPr>
        <p:spPr>
          <a:xfrm>
            <a:off x="3059280" y="404640"/>
            <a:ext cx="4572000" cy="175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1.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 HepG2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2.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 HepG2 </a:t>
            </a: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stimulated with IL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3.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 MOCK cells (HepG2 stably transfected with empty vector)                                    </a:t>
            </a: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4.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 MOCK cells </a:t>
            </a: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stimulated with IL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5.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 mI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κ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B cells (HepG2 stably transfected with mutant form of 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κ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 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inhibito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6.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 mI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κ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B cells </a:t>
            </a: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stimulated with IL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39320" y="873000"/>
            <a:ext cx="57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NFk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806400" y="996840"/>
            <a:ext cx="36036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263600" y="387360"/>
            <a:ext cx="1746360" cy="3494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44440" y="4325040"/>
            <a:ext cx="86486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1. Activation of NFκB in HepG2, MOCK and mIκB cel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clear extract was isolated from HepG2 cells, MOCK cells and mIκB cells. Where indicated cells were stimulated with IL-1β (15ng/ml). By gel retardation assay NFκB activation was measur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02T12:06:12Z</dcterms:created>
  <dc:creator>x</dc:creator>
  <dc:description/>
  <dc:language>en-US</dc:language>
  <cp:lastModifiedBy>Kate Mosford</cp:lastModifiedBy>
  <dcterms:modified xsi:type="dcterms:W3CDTF">2010-01-21T15:59:41Z</dcterms:modified>
  <cp:revision>42</cp:revision>
  <dc:subject/>
  <dc:title>Slajd 1</dc:title>
</cp:coreProperties>
</file>